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8" r:id="rId3"/>
    <p:sldId id="259" r:id="rId4"/>
    <p:sldId id="260" r:id="rId5"/>
    <p:sldId id="256" r:id="rId6"/>
  </p:sldIdLst>
  <p:sldSz cx="9236075" cy="109728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20022" autoAdjust="0"/>
    <p:restoredTop sz="94660"/>
  </p:normalViewPr>
  <p:slideViewPr>
    <p:cSldViewPr snapToGrid="0">
      <p:cViewPr>
        <p:scale>
          <a:sx n="53" d="100"/>
          <a:sy n="53" d="100"/>
        </p:scale>
        <p:origin x="2946" y="7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92706" y="1795781"/>
            <a:ext cx="7850664" cy="3820160"/>
          </a:xfrm>
        </p:spPr>
        <p:txBody>
          <a:bodyPr anchor="b"/>
          <a:lstStyle>
            <a:lvl1pPr algn="ctr">
              <a:defRPr sz="6061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54510" y="5763261"/>
            <a:ext cx="6927056" cy="2649219"/>
          </a:xfrm>
        </p:spPr>
        <p:txBody>
          <a:bodyPr/>
          <a:lstStyle>
            <a:lvl1pPr marL="0" indent="0" algn="ctr">
              <a:buNone/>
              <a:defRPr sz="2424"/>
            </a:lvl1pPr>
            <a:lvl2pPr marL="461818" indent="0" algn="ctr">
              <a:buNone/>
              <a:defRPr sz="2020"/>
            </a:lvl2pPr>
            <a:lvl3pPr marL="923635" indent="0" algn="ctr">
              <a:buNone/>
              <a:defRPr sz="1818"/>
            </a:lvl3pPr>
            <a:lvl4pPr marL="1385453" indent="0" algn="ctr">
              <a:buNone/>
              <a:defRPr sz="1616"/>
            </a:lvl4pPr>
            <a:lvl5pPr marL="1847271" indent="0" algn="ctr">
              <a:buNone/>
              <a:defRPr sz="1616"/>
            </a:lvl5pPr>
            <a:lvl6pPr marL="2309089" indent="0" algn="ctr">
              <a:buNone/>
              <a:defRPr sz="1616"/>
            </a:lvl6pPr>
            <a:lvl7pPr marL="2770906" indent="0" algn="ctr">
              <a:buNone/>
              <a:defRPr sz="1616"/>
            </a:lvl7pPr>
            <a:lvl8pPr marL="3232724" indent="0" algn="ctr">
              <a:buNone/>
              <a:defRPr sz="1616"/>
            </a:lvl8pPr>
            <a:lvl9pPr marL="3694542" indent="0" algn="ctr">
              <a:buNone/>
              <a:defRPr sz="1616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23205-4EA6-46E8-9940-E09CE9B5C1C5}" type="datetimeFigureOut">
              <a:rPr lang="en-US" smtClean="0"/>
              <a:t>8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60ED02-840A-4B26-B2F7-B3F065661B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91708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23205-4EA6-46E8-9940-E09CE9B5C1C5}" type="datetimeFigureOut">
              <a:rPr lang="en-US" smtClean="0"/>
              <a:t>8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60ED02-840A-4B26-B2F7-B3F065661B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73787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09567" y="584200"/>
            <a:ext cx="1991529" cy="9298941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34981" y="584200"/>
            <a:ext cx="5859135" cy="9298941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23205-4EA6-46E8-9940-E09CE9B5C1C5}" type="datetimeFigureOut">
              <a:rPr lang="en-US" smtClean="0"/>
              <a:t>8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60ED02-840A-4B26-B2F7-B3F065661B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21703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23205-4EA6-46E8-9940-E09CE9B5C1C5}" type="datetimeFigureOut">
              <a:rPr lang="en-US" smtClean="0"/>
              <a:t>8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60ED02-840A-4B26-B2F7-B3F065661B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60298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30170" y="2735583"/>
            <a:ext cx="7966115" cy="4564379"/>
          </a:xfrm>
        </p:spPr>
        <p:txBody>
          <a:bodyPr anchor="b"/>
          <a:lstStyle>
            <a:lvl1pPr>
              <a:defRPr sz="6061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30170" y="7343143"/>
            <a:ext cx="7966115" cy="2400299"/>
          </a:xfrm>
        </p:spPr>
        <p:txBody>
          <a:bodyPr/>
          <a:lstStyle>
            <a:lvl1pPr marL="0" indent="0">
              <a:buNone/>
              <a:defRPr sz="2424">
                <a:solidFill>
                  <a:schemeClr val="tx1"/>
                </a:solidFill>
              </a:defRPr>
            </a:lvl1pPr>
            <a:lvl2pPr marL="461818" indent="0">
              <a:buNone/>
              <a:defRPr sz="2020">
                <a:solidFill>
                  <a:schemeClr val="tx1">
                    <a:tint val="75000"/>
                  </a:schemeClr>
                </a:solidFill>
              </a:defRPr>
            </a:lvl2pPr>
            <a:lvl3pPr marL="923635" indent="0">
              <a:buNone/>
              <a:defRPr sz="1818">
                <a:solidFill>
                  <a:schemeClr val="tx1">
                    <a:tint val="75000"/>
                  </a:schemeClr>
                </a:solidFill>
              </a:defRPr>
            </a:lvl3pPr>
            <a:lvl4pPr marL="1385453" indent="0">
              <a:buNone/>
              <a:defRPr sz="1616">
                <a:solidFill>
                  <a:schemeClr val="tx1">
                    <a:tint val="75000"/>
                  </a:schemeClr>
                </a:solidFill>
              </a:defRPr>
            </a:lvl4pPr>
            <a:lvl5pPr marL="1847271" indent="0">
              <a:buNone/>
              <a:defRPr sz="1616">
                <a:solidFill>
                  <a:schemeClr val="tx1">
                    <a:tint val="75000"/>
                  </a:schemeClr>
                </a:solidFill>
              </a:defRPr>
            </a:lvl5pPr>
            <a:lvl6pPr marL="2309089" indent="0">
              <a:buNone/>
              <a:defRPr sz="1616">
                <a:solidFill>
                  <a:schemeClr val="tx1">
                    <a:tint val="75000"/>
                  </a:schemeClr>
                </a:solidFill>
              </a:defRPr>
            </a:lvl6pPr>
            <a:lvl7pPr marL="2770906" indent="0">
              <a:buNone/>
              <a:defRPr sz="1616">
                <a:solidFill>
                  <a:schemeClr val="tx1">
                    <a:tint val="75000"/>
                  </a:schemeClr>
                </a:solidFill>
              </a:defRPr>
            </a:lvl7pPr>
            <a:lvl8pPr marL="3232724" indent="0">
              <a:buNone/>
              <a:defRPr sz="1616">
                <a:solidFill>
                  <a:schemeClr val="tx1">
                    <a:tint val="75000"/>
                  </a:schemeClr>
                </a:solidFill>
              </a:defRPr>
            </a:lvl8pPr>
            <a:lvl9pPr marL="3694542" indent="0">
              <a:buNone/>
              <a:defRPr sz="161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23205-4EA6-46E8-9940-E09CE9B5C1C5}" type="datetimeFigureOut">
              <a:rPr lang="en-US" smtClean="0"/>
              <a:t>8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60ED02-840A-4B26-B2F7-B3F065661B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58035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34980" y="2921000"/>
            <a:ext cx="3925332" cy="6962141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75763" y="2921000"/>
            <a:ext cx="3925332" cy="6962141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23205-4EA6-46E8-9940-E09CE9B5C1C5}" type="datetimeFigureOut">
              <a:rPr lang="en-US" smtClean="0"/>
              <a:t>8/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60ED02-840A-4B26-B2F7-B3F065661B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16242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36183" y="584202"/>
            <a:ext cx="7966115" cy="2120901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36184" y="2689861"/>
            <a:ext cx="3907292" cy="1318259"/>
          </a:xfrm>
        </p:spPr>
        <p:txBody>
          <a:bodyPr anchor="b"/>
          <a:lstStyle>
            <a:lvl1pPr marL="0" indent="0">
              <a:buNone/>
              <a:defRPr sz="2424" b="1"/>
            </a:lvl1pPr>
            <a:lvl2pPr marL="461818" indent="0">
              <a:buNone/>
              <a:defRPr sz="2020" b="1"/>
            </a:lvl2pPr>
            <a:lvl3pPr marL="923635" indent="0">
              <a:buNone/>
              <a:defRPr sz="1818" b="1"/>
            </a:lvl3pPr>
            <a:lvl4pPr marL="1385453" indent="0">
              <a:buNone/>
              <a:defRPr sz="1616" b="1"/>
            </a:lvl4pPr>
            <a:lvl5pPr marL="1847271" indent="0">
              <a:buNone/>
              <a:defRPr sz="1616" b="1"/>
            </a:lvl5pPr>
            <a:lvl6pPr marL="2309089" indent="0">
              <a:buNone/>
              <a:defRPr sz="1616" b="1"/>
            </a:lvl6pPr>
            <a:lvl7pPr marL="2770906" indent="0">
              <a:buNone/>
              <a:defRPr sz="1616" b="1"/>
            </a:lvl7pPr>
            <a:lvl8pPr marL="3232724" indent="0">
              <a:buNone/>
              <a:defRPr sz="1616" b="1"/>
            </a:lvl8pPr>
            <a:lvl9pPr marL="3694542" indent="0">
              <a:buNone/>
              <a:defRPr sz="1616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36184" y="4008120"/>
            <a:ext cx="3907292" cy="5895341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75763" y="2689861"/>
            <a:ext cx="3926535" cy="1318259"/>
          </a:xfrm>
        </p:spPr>
        <p:txBody>
          <a:bodyPr anchor="b"/>
          <a:lstStyle>
            <a:lvl1pPr marL="0" indent="0">
              <a:buNone/>
              <a:defRPr sz="2424" b="1"/>
            </a:lvl1pPr>
            <a:lvl2pPr marL="461818" indent="0">
              <a:buNone/>
              <a:defRPr sz="2020" b="1"/>
            </a:lvl2pPr>
            <a:lvl3pPr marL="923635" indent="0">
              <a:buNone/>
              <a:defRPr sz="1818" b="1"/>
            </a:lvl3pPr>
            <a:lvl4pPr marL="1385453" indent="0">
              <a:buNone/>
              <a:defRPr sz="1616" b="1"/>
            </a:lvl4pPr>
            <a:lvl5pPr marL="1847271" indent="0">
              <a:buNone/>
              <a:defRPr sz="1616" b="1"/>
            </a:lvl5pPr>
            <a:lvl6pPr marL="2309089" indent="0">
              <a:buNone/>
              <a:defRPr sz="1616" b="1"/>
            </a:lvl6pPr>
            <a:lvl7pPr marL="2770906" indent="0">
              <a:buNone/>
              <a:defRPr sz="1616" b="1"/>
            </a:lvl7pPr>
            <a:lvl8pPr marL="3232724" indent="0">
              <a:buNone/>
              <a:defRPr sz="1616" b="1"/>
            </a:lvl8pPr>
            <a:lvl9pPr marL="3694542" indent="0">
              <a:buNone/>
              <a:defRPr sz="1616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75763" y="4008120"/>
            <a:ext cx="3926535" cy="5895341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23205-4EA6-46E8-9940-E09CE9B5C1C5}" type="datetimeFigureOut">
              <a:rPr lang="en-US" smtClean="0"/>
              <a:t>8/1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60ED02-840A-4B26-B2F7-B3F065661B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87361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23205-4EA6-46E8-9940-E09CE9B5C1C5}" type="datetimeFigureOut">
              <a:rPr lang="en-US" smtClean="0"/>
              <a:t>8/1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60ED02-840A-4B26-B2F7-B3F065661B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11774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23205-4EA6-46E8-9940-E09CE9B5C1C5}" type="datetimeFigureOut">
              <a:rPr lang="en-US" smtClean="0"/>
              <a:t>8/1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60ED02-840A-4B26-B2F7-B3F065661B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26897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36183" y="731520"/>
            <a:ext cx="2978875" cy="2560320"/>
          </a:xfrm>
        </p:spPr>
        <p:txBody>
          <a:bodyPr anchor="b"/>
          <a:lstStyle>
            <a:lvl1pPr>
              <a:defRPr sz="3232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926535" y="1579882"/>
            <a:ext cx="4675763" cy="7797800"/>
          </a:xfrm>
        </p:spPr>
        <p:txBody>
          <a:bodyPr/>
          <a:lstStyle>
            <a:lvl1pPr>
              <a:defRPr sz="3232"/>
            </a:lvl1pPr>
            <a:lvl2pPr>
              <a:defRPr sz="2828"/>
            </a:lvl2pPr>
            <a:lvl3pPr>
              <a:defRPr sz="2424"/>
            </a:lvl3pPr>
            <a:lvl4pPr>
              <a:defRPr sz="2020"/>
            </a:lvl4pPr>
            <a:lvl5pPr>
              <a:defRPr sz="2020"/>
            </a:lvl5pPr>
            <a:lvl6pPr>
              <a:defRPr sz="2020"/>
            </a:lvl6pPr>
            <a:lvl7pPr>
              <a:defRPr sz="2020"/>
            </a:lvl7pPr>
            <a:lvl8pPr>
              <a:defRPr sz="2020"/>
            </a:lvl8pPr>
            <a:lvl9pPr>
              <a:defRPr sz="202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36183" y="3291840"/>
            <a:ext cx="2978875" cy="6098541"/>
          </a:xfrm>
        </p:spPr>
        <p:txBody>
          <a:bodyPr/>
          <a:lstStyle>
            <a:lvl1pPr marL="0" indent="0">
              <a:buNone/>
              <a:defRPr sz="1616"/>
            </a:lvl1pPr>
            <a:lvl2pPr marL="461818" indent="0">
              <a:buNone/>
              <a:defRPr sz="1414"/>
            </a:lvl2pPr>
            <a:lvl3pPr marL="923635" indent="0">
              <a:buNone/>
              <a:defRPr sz="1212"/>
            </a:lvl3pPr>
            <a:lvl4pPr marL="1385453" indent="0">
              <a:buNone/>
              <a:defRPr sz="1010"/>
            </a:lvl4pPr>
            <a:lvl5pPr marL="1847271" indent="0">
              <a:buNone/>
              <a:defRPr sz="1010"/>
            </a:lvl5pPr>
            <a:lvl6pPr marL="2309089" indent="0">
              <a:buNone/>
              <a:defRPr sz="1010"/>
            </a:lvl6pPr>
            <a:lvl7pPr marL="2770906" indent="0">
              <a:buNone/>
              <a:defRPr sz="1010"/>
            </a:lvl7pPr>
            <a:lvl8pPr marL="3232724" indent="0">
              <a:buNone/>
              <a:defRPr sz="1010"/>
            </a:lvl8pPr>
            <a:lvl9pPr marL="3694542" indent="0">
              <a:buNone/>
              <a:defRPr sz="101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23205-4EA6-46E8-9940-E09CE9B5C1C5}" type="datetimeFigureOut">
              <a:rPr lang="en-US" smtClean="0"/>
              <a:t>8/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60ED02-840A-4B26-B2F7-B3F065661B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49788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36183" y="731520"/>
            <a:ext cx="2978875" cy="2560320"/>
          </a:xfrm>
        </p:spPr>
        <p:txBody>
          <a:bodyPr anchor="b"/>
          <a:lstStyle>
            <a:lvl1pPr>
              <a:defRPr sz="3232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926535" y="1579882"/>
            <a:ext cx="4675763" cy="7797800"/>
          </a:xfrm>
        </p:spPr>
        <p:txBody>
          <a:bodyPr anchor="t"/>
          <a:lstStyle>
            <a:lvl1pPr marL="0" indent="0">
              <a:buNone/>
              <a:defRPr sz="3232"/>
            </a:lvl1pPr>
            <a:lvl2pPr marL="461818" indent="0">
              <a:buNone/>
              <a:defRPr sz="2828"/>
            </a:lvl2pPr>
            <a:lvl3pPr marL="923635" indent="0">
              <a:buNone/>
              <a:defRPr sz="2424"/>
            </a:lvl3pPr>
            <a:lvl4pPr marL="1385453" indent="0">
              <a:buNone/>
              <a:defRPr sz="2020"/>
            </a:lvl4pPr>
            <a:lvl5pPr marL="1847271" indent="0">
              <a:buNone/>
              <a:defRPr sz="2020"/>
            </a:lvl5pPr>
            <a:lvl6pPr marL="2309089" indent="0">
              <a:buNone/>
              <a:defRPr sz="2020"/>
            </a:lvl6pPr>
            <a:lvl7pPr marL="2770906" indent="0">
              <a:buNone/>
              <a:defRPr sz="2020"/>
            </a:lvl7pPr>
            <a:lvl8pPr marL="3232724" indent="0">
              <a:buNone/>
              <a:defRPr sz="2020"/>
            </a:lvl8pPr>
            <a:lvl9pPr marL="3694542" indent="0">
              <a:buNone/>
              <a:defRPr sz="202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36183" y="3291840"/>
            <a:ext cx="2978875" cy="6098541"/>
          </a:xfrm>
        </p:spPr>
        <p:txBody>
          <a:bodyPr/>
          <a:lstStyle>
            <a:lvl1pPr marL="0" indent="0">
              <a:buNone/>
              <a:defRPr sz="1616"/>
            </a:lvl1pPr>
            <a:lvl2pPr marL="461818" indent="0">
              <a:buNone/>
              <a:defRPr sz="1414"/>
            </a:lvl2pPr>
            <a:lvl3pPr marL="923635" indent="0">
              <a:buNone/>
              <a:defRPr sz="1212"/>
            </a:lvl3pPr>
            <a:lvl4pPr marL="1385453" indent="0">
              <a:buNone/>
              <a:defRPr sz="1010"/>
            </a:lvl4pPr>
            <a:lvl5pPr marL="1847271" indent="0">
              <a:buNone/>
              <a:defRPr sz="1010"/>
            </a:lvl5pPr>
            <a:lvl6pPr marL="2309089" indent="0">
              <a:buNone/>
              <a:defRPr sz="1010"/>
            </a:lvl6pPr>
            <a:lvl7pPr marL="2770906" indent="0">
              <a:buNone/>
              <a:defRPr sz="1010"/>
            </a:lvl7pPr>
            <a:lvl8pPr marL="3232724" indent="0">
              <a:buNone/>
              <a:defRPr sz="1010"/>
            </a:lvl8pPr>
            <a:lvl9pPr marL="3694542" indent="0">
              <a:buNone/>
              <a:defRPr sz="101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23205-4EA6-46E8-9940-E09CE9B5C1C5}" type="datetimeFigureOut">
              <a:rPr lang="en-US" smtClean="0"/>
              <a:t>8/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60ED02-840A-4B26-B2F7-B3F065661B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14386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34980" y="584202"/>
            <a:ext cx="7966115" cy="212090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34980" y="2921000"/>
            <a:ext cx="7966115" cy="696214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34980" y="10170162"/>
            <a:ext cx="2078117" cy="5842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1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B23205-4EA6-46E8-9940-E09CE9B5C1C5}" type="datetimeFigureOut">
              <a:rPr lang="en-US" smtClean="0"/>
              <a:t>8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59450" y="10170162"/>
            <a:ext cx="3117175" cy="5842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1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22978" y="10170162"/>
            <a:ext cx="2078117" cy="5842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1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60ED02-840A-4B26-B2F7-B3F065661B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88367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23635" rtl="0" eaLnBrk="1" latinLnBrk="0" hangingPunct="1">
        <a:lnSpc>
          <a:spcPct val="90000"/>
        </a:lnSpc>
        <a:spcBef>
          <a:spcPct val="0"/>
        </a:spcBef>
        <a:buNone/>
        <a:defRPr sz="444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30909" indent="-230909" algn="l" defTabSz="923635" rtl="0" eaLnBrk="1" latinLnBrk="0" hangingPunct="1">
        <a:lnSpc>
          <a:spcPct val="90000"/>
        </a:lnSpc>
        <a:spcBef>
          <a:spcPts val="1010"/>
        </a:spcBef>
        <a:buFont typeface="Arial" panose="020B0604020202020204" pitchFamily="34" charset="0"/>
        <a:buChar char="•"/>
        <a:defRPr sz="2828" kern="1200">
          <a:solidFill>
            <a:schemeClr val="tx1"/>
          </a:solidFill>
          <a:latin typeface="+mn-lt"/>
          <a:ea typeface="+mn-ea"/>
          <a:cs typeface="+mn-cs"/>
        </a:defRPr>
      </a:lvl1pPr>
      <a:lvl2pPr marL="692727" indent="-230909" algn="l" defTabSz="923635" rtl="0" eaLnBrk="1" latinLnBrk="0" hangingPunct="1">
        <a:lnSpc>
          <a:spcPct val="90000"/>
        </a:lnSpc>
        <a:spcBef>
          <a:spcPts val="505"/>
        </a:spcBef>
        <a:buFont typeface="Arial" panose="020B0604020202020204" pitchFamily="34" charset="0"/>
        <a:buChar char="•"/>
        <a:defRPr sz="2424" kern="1200">
          <a:solidFill>
            <a:schemeClr val="tx1"/>
          </a:solidFill>
          <a:latin typeface="+mn-lt"/>
          <a:ea typeface="+mn-ea"/>
          <a:cs typeface="+mn-cs"/>
        </a:defRPr>
      </a:lvl2pPr>
      <a:lvl3pPr marL="1154544" indent="-230909" algn="l" defTabSz="923635" rtl="0" eaLnBrk="1" latinLnBrk="0" hangingPunct="1">
        <a:lnSpc>
          <a:spcPct val="90000"/>
        </a:lnSpc>
        <a:spcBef>
          <a:spcPts val="505"/>
        </a:spcBef>
        <a:buFont typeface="Arial" panose="020B0604020202020204" pitchFamily="34" charset="0"/>
        <a:buChar char="•"/>
        <a:defRPr sz="2020" kern="1200">
          <a:solidFill>
            <a:schemeClr val="tx1"/>
          </a:solidFill>
          <a:latin typeface="+mn-lt"/>
          <a:ea typeface="+mn-ea"/>
          <a:cs typeface="+mn-cs"/>
        </a:defRPr>
      </a:lvl3pPr>
      <a:lvl4pPr marL="1616362" indent="-230909" algn="l" defTabSz="923635" rtl="0" eaLnBrk="1" latinLnBrk="0" hangingPunct="1">
        <a:lnSpc>
          <a:spcPct val="90000"/>
        </a:lnSpc>
        <a:spcBef>
          <a:spcPts val="505"/>
        </a:spcBef>
        <a:buFont typeface="Arial" panose="020B0604020202020204" pitchFamily="34" charset="0"/>
        <a:buChar char="•"/>
        <a:defRPr sz="1818" kern="1200">
          <a:solidFill>
            <a:schemeClr val="tx1"/>
          </a:solidFill>
          <a:latin typeface="+mn-lt"/>
          <a:ea typeface="+mn-ea"/>
          <a:cs typeface="+mn-cs"/>
        </a:defRPr>
      </a:lvl4pPr>
      <a:lvl5pPr marL="2078180" indent="-230909" algn="l" defTabSz="923635" rtl="0" eaLnBrk="1" latinLnBrk="0" hangingPunct="1">
        <a:lnSpc>
          <a:spcPct val="90000"/>
        </a:lnSpc>
        <a:spcBef>
          <a:spcPts val="505"/>
        </a:spcBef>
        <a:buFont typeface="Arial" panose="020B0604020202020204" pitchFamily="34" charset="0"/>
        <a:buChar char="•"/>
        <a:defRPr sz="1818" kern="1200">
          <a:solidFill>
            <a:schemeClr val="tx1"/>
          </a:solidFill>
          <a:latin typeface="+mn-lt"/>
          <a:ea typeface="+mn-ea"/>
          <a:cs typeface="+mn-cs"/>
        </a:defRPr>
      </a:lvl5pPr>
      <a:lvl6pPr marL="2539997" indent="-230909" algn="l" defTabSz="923635" rtl="0" eaLnBrk="1" latinLnBrk="0" hangingPunct="1">
        <a:lnSpc>
          <a:spcPct val="90000"/>
        </a:lnSpc>
        <a:spcBef>
          <a:spcPts val="505"/>
        </a:spcBef>
        <a:buFont typeface="Arial" panose="020B0604020202020204" pitchFamily="34" charset="0"/>
        <a:buChar char="•"/>
        <a:defRPr sz="1818" kern="1200">
          <a:solidFill>
            <a:schemeClr val="tx1"/>
          </a:solidFill>
          <a:latin typeface="+mn-lt"/>
          <a:ea typeface="+mn-ea"/>
          <a:cs typeface="+mn-cs"/>
        </a:defRPr>
      </a:lvl6pPr>
      <a:lvl7pPr marL="3001815" indent="-230909" algn="l" defTabSz="923635" rtl="0" eaLnBrk="1" latinLnBrk="0" hangingPunct="1">
        <a:lnSpc>
          <a:spcPct val="90000"/>
        </a:lnSpc>
        <a:spcBef>
          <a:spcPts val="505"/>
        </a:spcBef>
        <a:buFont typeface="Arial" panose="020B0604020202020204" pitchFamily="34" charset="0"/>
        <a:buChar char="•"/>
        <a:defRPr sz="1818" kern="1200">
          <a:solidFill>
            <a:schemeClr val="tx1"/>
          </a:solidFill>
          <a:latin typeface="+mn-lt"/>
          <a:ea typeface="+mn-ea"/>
          <a:cs typeface="+mn-cs"/>
        </a:defRPr>
      </a:lvl7pPr>
      <a:lvl8pPr marL="3463633" indent="-230909" algn="l" defTabSz="923635" rtl="0" eaLnBrk="1" latinLnBrk="0" hangingPunct="1">
        <a:lnSpc>
          <a:spcPct val="90000"/>
        </a:lnSpc>
        <a:spcBef>
          <a:spcPts val="505"/>
        </a:spcBef>
        <a:buFont typeface="Arial" panose="020B0604020202020204" pitchFamily="34" charset="0"/>
        <a:buChar char="•"/>
        <a:defRPr sz="1818" kern="1200">
          <a:solidFill>
            <a:schemeClr val="tx1"/>
          </a:solidFill>
          <a:latin typeface="+mn-lt"/>
          <a:ea typeface="+mn-ea"/>
          <a:cs typeface="+mn-cs"/>
        </a:defRPr>
      </a:lvl8pPr>
      <a:lvl9pPr marL="3925451" indent="-230909" algn="l" defTabSz="923635" rtl="0" eaLnBrk="1" latinLnBrk="0" hangingPunct="1">
        <a:lnSpc>
          <a:spcPct val="90000"/>
        </a:lnSpc>
        <a:spcBef>
          <a:spcPts val="505"/>
        </a:spcBef>
        <a:buFont typeface="Arial" panose="020B0604020202020204" pitchFamily="34" charset="0"/>
        <a:buChar char="•"/>
        <a:defRPr sz="181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23635" rtl="0" eaLnBrk="1" latinLnBrk="0" hangingPunct="1">
        <a:defRPr sz="1818" kern="1200">
          <a:solidFill>
            <a:schemeClr val="tx1"/>
          </a:solidFill>
          <a:latin typeface="+mn-lt"/>
          <a:ea typeface="+mn-ea"/>
          <a:cs typeface="+mn-cs"/>
        </a:defRPr>
      </a:lvl1pPr>
      <a:lvl2pPr marL="461818" algn="l" defTabSz="923635" rtl="0" eaLnBrk="1" latinLnBrk="0" hangingPunct="1">
        <a:defRPr sz="1818" kern="1200">
          <a:solidFill>
            <a:schemeClr val="tx1"/>
          </a:solidFill>
          <a:latin typeface="+mn-lt"/>
          <a:ea typeface="+mn-ea"/>
          <a:cs typeface="+mn-cs"/>
        </a:defRPr>
      </a:lvl2pPr>
      <a:lvl3pPr marL="923635" algn="l" defTabSz="923635" rtl="0" eaLnBrk="1" latinLnBrk="0" hangingPunct="1">
        <a:defRPr sz="1818" kern="1200">
          <a:solidFill>
            <a:schemeClr val="tx1"/>
          </a:solidFill>
          <a:latin typeface="+mn-lt"/>
          <a:ea typeface="+mn-ea"/>
          <a:cs typeface="+mn-cs"/>
        </a:defRPr>
      </a:lvl3pPr>
      <a:lvl4pPr marL="1385453" algn="l" defTabSz="923635" rtl="0" eaLnBrk="1" latinLnBrk="0" hangingPunct="1">
        <a:defRPr sz="1818" kern="1200">
          <a:solidFill>
            <a:schemeClr val="tx1"/>
          </a:solidFill>
          <a:latin typeface="+mn-lt"/>
          <a:ea typeface="+mn-ea"/>
          <a:cs typeface="+mn-cs"/>
        </a:defRPr>
      </a:lvl4pPr>
      <a:lvl5pPr marL="1847271" algn="l" defTabSz="923635" rtl="0" eaLnBrk="1" latinLnBrk="0" hangingPunct="1">
        <a:defRPr sz="1818" kern="1200">
          <a:solidFill>
            <a:schemeClr val="tx1"/>
          </a:solidFill>
          <a:latin typeface="+mn-lt"/>
          <a:ea typeface="+mn-ea"/>
          <a:cs typeface="+mn-cs"/>
        </a:defRPr>
      </a:lvl5pPr>
      <a:lvl6pPr marL="2309089" algn="l" defTabSz="923635" rtl="0" eaLnBrk="1" latinLnBrk="0" hangingPunct="1">
        <a:defRPr sz="1818" kern="1200">
          <a:solidFill>
            <a:schemeClr val="tx1"/>
          </a:solidFill>
          <a:latin typeface="+mn-lt"/>
          <a:ea typeface="+mn-ea"/>
          <a:cs typeface="+mn-cs"/>
        </a:defRPr>
      </a:lvl6pPr>
      <a:lvl7pPr marL="2770906" algn="l" defTabSz="923635" rtl="0" eaLnBrk="1" latinLnBrk="0" hangingPunct="1">
        <a:defRPr sz="1818" kern="1200">
          <a:solidFill>
            <a:schemeClr val="tx1"/>
          </a:solidFill>
          <a:latin typeface="+mn-lt"/>
          <a:ea typeface="+mn-ea"/>
          <a:cs typeface="+mn-cs"/>
        </a:defRPr>
      </a:lvl7pPr>
      <a:lvl8pPr marL="3232724" algn="l" defTabSz="923635" rtl="0" eaLnBrk="1" latinLnBrk="0" hangingPunct="1">
        <a:defRPr sz="1818" kern="1200">
          <a:solidFill>
            <a:schemeClr val="tx1"/>
          </a:solidFill>
          <a:latin typeface="+mn-lt"/>
          <a:ea typeface="+mn-ea"/>
          <a:cs typeface="+mn-cs"/>
        </a:defRPr>
      </a:lvl8pPr>
      <a:lvl9pPr marL="3694542" algn="l" defTabSz="923635" rtl="0" eaLnBrk="1" latinLnBrk="0" hangingPunct="1">
        <a:defRPr sz="181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" name="Picture 2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67301" y="1802731"/>
            <a:ext cx="5715000" cy="4276725"/>
          </a:xfrm>
          <a:prstGeom prst="rect">
            <a:avLst/>
          </a:prstGeom>
        </p:spPr>
      </p:pic>
      <p:cxnSp>
        <p:nvCxnSpPr>
          <p:cNvPr id="4" name="Straight Connector 3"/>
          <p:cNvCxnSpPr/>
          <p:nvPr/>
        </p:nvCxnSpPr>
        <p:spPr>
          <a:xfrm flipH="1">
            <a:off x="1600195" y="4400097"/>
            <a:ext cx="21515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Connector 4"/>
          <p:cNvCxnSpPr/>
          <p:nvPr/>
        </p:nvCxnSpPr>
        <p:spPr>
          <a:xfrm flipH="1">
            <a:off x="1612153" y="3991926"/>
            <a:ext cx="21515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 flipH="1">
            <a:off x="1612154" y="3765162"/>
            <a:ext cx="21515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 flipH="1">
            <a:off x="1612155" y="3591447"/>
            <a:ext cx="21515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/>
          <p:cNvCxnSpPr/>
          <p:nvPr/>
        </p:nvCxnSpPr>
        <p:spPr>
          <a:xfrm flipH="1">
            <a:off x="1614888" y="3458920"/>
            <a:ext cx="21515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/>
          <p:cNvCxnSpPr/>
          <p:nvPr/>
        </p:nvCxnSpPr>
        <p:spPr>
          <a:xfrm flipH="1">
            <a:off x="1614889" y="3215148"/>
            <a:ext cx="21515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 flipH="1">
            <a:off x="1618120" y="2997567"/>
            <a:ext cx="21515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 flipH="1">
            <a:off x="1618120" y="2854132"/>
            <a:ext cx="21515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1277596" y="4284681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1273501" y="3891054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273501" y="3645495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AU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0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1270700" y="3467507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400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1276301" y="3313927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AU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0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264924" y="3138323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800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1200804" y="2865824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500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1200804" y="2735542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3000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Straight Connector 19"/>
          <p:cNvCxnSpPr/>
          <p:nvPr/>
        </p:nvCxnSpPr>
        <p:spPr>
          <a:xfrm flipH="1">
            <a:off x="1614889" y="3120026"/>
            <a:ext cx="21515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1200804" y="3019339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1329044" y="2535904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2977231" y="1516370"/>
            <a:ext cx="72359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>
                <a:latin typeface="Arial" panose="020B0604020202020204" pitchFamily="34" charset="0"/>
                <a:cs typeface="Arial" panose="020B0604020202020204" pitchFamily="34" charset="0"/>
              </a:rPr>
              <a:t>   M     1      2    3     4     5    6   NTC    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1830042" y="6188975"/>
            <a:ext cx="4956806" cy="28623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M: 100-bp DNA ladder</a:t>
            </a:r>
          </a:p>
          <a:p>
            <a:r>
              <a:rPr lang="en-AU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1: Human </a:t>
            </a:r>
            <a:r>
              <a:rPr lang="en-AU" sz="2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PSCs</a:t>
            </a:r>
            <a:r>
              <a:rPr lang="en-AU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 019</a:t>
            </a:r>
          </a:p>
          <a:p>
            <a:r>
              <a:rPr lang="en-AU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2: 5-Day 2D culture of human </a:t>
            </a:r>
            <a:r>
              <a:rPr lang="en-AU" sz="2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PSCs</a:t>
            </a:r>
            <a:r>
              <a:rPr lang="en-AU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 019</a:t>
            </a:r>
          </a:p>
          <a:p>
            <a:r>
              <a:rPr lang="en-AU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3: 10-Day 2D culture </a:t>
            </a:r>
            <a:r>
              <a:rPr lang="en-AU" sz="2000" dirty="0">
                <a:latin typeface="Arial" panose="020B0604020202020204" pitchFamily="34" charset="0"/>
                <a:cs typeface="Arial" panose="020B0604020202020204" pitchFamily="34" charset="0"/>
              </a:rPr>
              <a:t>of human </a:t>
            </a:r>
            <a:r>
              <a:rPr lang="en-AU" sz="2000" dirty="0" err="1">
                <a:latin typeface="Arial" panose="020B0604020202020204" pitchFamily="34" charset="0"/>
                <a:cs typeface="Arial" panose="020B0604020202020204" pitchFamily="34" charset="0"/>
              </a:rPr>
              <a:t>iPSCs</a:t>
            </a:r>
            <a:r>
              <a:rPr lang="en-AU" sz="2000" dirty="0">
                <a:latin typeface="Arial" panose="020B0604020202020204" pitchFamily="34" charset="0"/>
                <a:cs typeface="Arial" panose="020B0604020202020204" pitchFamily="34" charset="0"/>
              </a:rPr>
              <a:t> 019</a:t>
            </a:r>
          </a:p>
          <a:p>
            <a:r>
              <a:rPr lang="en-AU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4: 15-Day </a:t>
            </a:r>
            <a:r>
              <a:rPr lang="en-AU" sz="2000" dirty="0">
                <a:latin typeface="Arial" panose="020B0604020202020204" pitchFamily="34" charset="0"/>
                <a:cs typeface="Arial" panose="020B0604020202020204" pitchFamily="34" charset="0"/>
              </a:rPr>
              <a:t>2D culture of human </a:t>
            </a:r>
            <a:r>
              <a:rPr lang="en-AU" sz="2000" dirty="0" err="1">
                <a:latin typeface="Arial" panose="020B0604020202020204" pitchFamily="34" charset="0"/>
                <a:cs typeface="Arial" panose="020B0604020202020204" pitchFamily="34" charset="0"/>
              </a:rPr>
              <a:t>iPSCs</a:t>
            </a:r>
            <a:r>
              <a:rPr lang="en-AU" sz="2000" dirty="0">
                <a:latin typeface="Arial" panose="020B0604020202020204" pitchFamily="34" charset="0"/>
                <a:cs typeface="Arial" panose="020B0604020202020204" pitchFamily="34" charset="0"/>
              </a:rPr>
              <a:t> 019</a:t>
            </a:r>
          </a:p>
          <a:p>
            <a:r>
              <a:rPr lang="en-AU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5: 25-Day </a:t>
            </a:r>
            <a:r>
              <a:rPr lang="en-AU" sz="2000" dirty="0">
                <a:latin typeface="Arial" panose="020B0604020202020204" pitchFamily="34" charset="0"/>
                <a:cs typeface="Arial" panose="020B0604020202020204" pitchFamily="34" charset="0"/>
              </a:rPr>
              <a:t>2D culture of human </a:t>
            </a:r>
            <a:r>
              <a:rPr lang="en-AU" sz="2000" dirty="0" err="1">
                <a:latin typeface="Arial" panose="020B0604020202020204" pitchFamily="34" charset="0"/>
                <a:cs typeface="Arial" panose="020B0604020202020204" pitchFamily="34" charset="0"/>
              </a:rPr>
              <a:t>iPSCs</a:t>
            </a:r>
            <a:r>
              <a:rPr lang="en-AU" sz="2000" dirty="0">
                <a:latin typeface="Arial" panose="020B0604020202020204" pitchFamily="34" charset="0"/>
                <a:cs typeface="Arial" panose="020B0604020202020204" pitchFamily="34" charset="0"/>
              </a:rPr>
              <a:t> 019</a:t>
            </a:r>
          </a:p>
          <a:p>
            <a:r>
              <a:rPr lang="en-AU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6: 17-Day 3D </a:t>
            </a:r>
            <a:r>
              <a:rPr lang="en-AU" sz="2000" dirty="0">
                <a:latin typeface="Arial" panose="020B0604020202020204" pitchFamily="34" charset="0"/>
                <a:cs typeface="Arial" panose="020B0604020202020204" pitchFamily="34" charset="0"/>
              </a:rPr>
              <a:t>culture of human </a:t>
            </a:r>
            <a:r>
              <a:rPr lang="en-AU" sz="2000" dirty="0" err="1">
                <a:latin typeface="Arial" panose="020B0604020202020204" pitchFamily="34" charset="0"/>
                <a:cs typeface="Arial" panose="020B0604020202020204" pitchFamily="34" charset="0"/>
              </a:rPr>
              <a:t>iPSCs</a:t>
            </a:r>
            <a:r>
              <a:rPr lang="en-AU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AU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019</a:t>
            </a:r>
          </a:p>
          <a:p>
            <a:r>
              <a:rPr lang="en-AU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NTC: no template control</a:t>
            </a:r>
          </a:p>
          <a:p>
            <a:r>
              <a:rPr lang="en-AU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Arrow: expected size of amplicons</a:t>
            </a:r>
            <a:endParaRPr lang="en-AU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719729" y="1032948"/>
            <a:ext cx="190949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Human</a:t>
            </a:r>
            <a:r>
              <a:rPr lang="en-AU" sz="2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SOX17</a:t>
            </a:r>
            <a:endParaRPr lang="en-US" sz="2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8" name="Straight Arrow Connector 47"/>
          <p:cNvCxnSpPr/>
          <p:nvPr/>
        </p:nvCxnSpPr>
        <p:spPr>
          <a:xfrm flipH="1">
            <a:off x="7628219" y="3212294"/>
            <a:ext cx="357352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/>
          <p:cNvSpPr txBox="1"/>
          <p:nvPr/>
        </p:nvSpPr>
        <p:spPr>
          <a:xfrm>
            <a:off x="99152" y="109931"/>
            <a:ext cx="797526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AU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data: Raw data of agarose gel with labels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037933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64928" y="1672788"/>
            <a:ext cx="5715000" cy="4276725"/>
          </a:xfrm>
          <a:prstGeom prst="rect">
            <a:avLst/>
          </a:prstGeom>
        </p:spPr>
      </p:pic>
      <p:cxnSp>
        <p:nvCxnSpPr>
          <p:cNvPr id="4" name="Straight Connector 3"/>
          <p:cNvCxnSpPr/>
          <p:nvPr/>
        </p:nvCxnSpPr>
        <p:spPr>
          <a:xfrm flipH="1">
            <a:off x="1600195" y="4400097"/>
            <a:ext cx="21515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Connector 4"/>
          <p:cNvCxnSpPr/>
          <p:nvPr/>
        </p:nvCxnSpPr>
        <p:spPr>
          <a:xfrm flipH="1">
            <a:off x="1612153" y="4042166"/>
            <a:ext cx="21515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 flipH="1">
            <a:off x="1612154" y="3815402"/>
            <a:ext cx="21515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 flipH="1">
            <a:off x="1612155" y="3636663"/>
            <a:ext cx="21515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/>
          <p:cNvCxnSpPr/>
          <p:nvPr/>
        </p:nvCxnSpPr>
        <p:spPr>
          <a:xfrm flipH="1">
            <a:off x="1614888" y="3489064"/>
            <a:ext cx="21515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/>
          <p:cNvCxnSpPr/>
          <p:nvPr/>
        </p:nvCxnSpPr>
        <p:spPr>
          <a:xfrm flipH="1">
            <a:off x="1614889" y="3230220"/>
            <a:ext cx="21515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 flipH="1">
            <a:off x="1618120" y="2947327"/>
            <a:ext cx="21515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 flipH="1">
            <a:off x="1618120" y="2768724"/>
            <a:ext cx="21515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1277596" y="4284681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1273501" y="3941294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273501" y="3695735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AU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0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1270700" y="3522771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400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1281325" y="3359143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AU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0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264924" y="3123352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800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1200804" y="2820608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500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1200804" y="2650134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3000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Straight Connector 19"/>
          <p:cNvCxnSpPr/>
          <p:nvPr/>
        </p:nvCxnSpPr>
        <p:spPr>
          <a:xfrm flipH="1">
            <a:off x="1614889" y="3104954"/>
            <a:ext cx="21515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1200804" y="2989195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1329044" y="2450496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2972207" y="1368123"/>
            <a:ext cx="41576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>
                <a:latin typeface="Arial" panose="020B0604020202020204" pitchFamily="34" charset="0"/>
                <a:cs typeface="Arial" panose="020B0604020202020204" pitchFamily="34" charset="0"/>
              </a:rPr>
              <a:t>   M     1      2    3     4     5    6   NTC    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1830042" y="6188975"/>
            <a:ext cx="4956806" cy="28623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M: 100-bp DNA ladder</a:t>
            </a:r>
          </a:p>
          <a:p>
            <a:r>
              <a:rPr lang="en-AU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1: Human </a:t>
            </a:r>
            <a:r>
              <a:rPr lang="en-AU" sz="2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PSCs</a:t>
            </a:r>
            <a:r>
              <a:rPr lang="en-AU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 019</a:t>
            </a:r>
          </a:p>
          <a:p>
            <a:r>
              <a:rPr lang="en-AU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2: 5-Day 2D culture of human </a:t>
            </a:r>
            <a:r>
              <a:rPr lang="en-AU" sz="2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PSCs</a:t>
            </a:r>
            <a:r>
              <a:rPr lang="en-AU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 019</a:t>
            </a:r>
          </a:p>
          <a:p>
            <a:r>
              <a:rPr lang="en-AU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3: 10-Day 2D culture </a:t>
            </a:r>
            <a:r>
              <a:rPr lang="en-AU" sz="2000" dirty="0">
                <a:latin typeface="Arial" panose="020B0604020202020204" pitchFamily="34" charset="0"/>
                <a:cs typeface="Arial" panose="020B0604020202020204" pitchFamily="34" charset="0"/>
              </a:rPr>
              <a:t>of human </a:t>
            </a:r>
            <a:r>
              <a:rPr lang="en-AU" sz="2000" dirty="0" err="1">
                <a:latin typeface="Arial" panose="020B0604020202020204" pitchFamily="34" charset="0"/>
                <a:cs typeface="Arial" panose="020B0604020202020204" pitchFamily="34" charset="0"/>
              </a:rPr>
              <a:t>iPSCs</a:t>
            </a:r>
            <a:r>
              <a:rPr lang="en-AU" sz="2000" dirty="0">
                <a:latin typeface="Arial" panose="020B0604020202020204" pitchFamily="34" charset="0"/>
                <a:cs typeface="Arial" panose="020B0604020202020204" pitchFamily="34" charset="0"/>
              </a:rPr>
              <a:t> 019</a:t>
            </a:r>
          </a:p>
          <a:p>
            <a:r>
              <a:rPr lang="en-AU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4: 15-Day </a:t>
            </a:r>
            <a:r>
              <a:rPr lang="en-AU" sz="2000" dirty="0">
                <a:latin typeface="Arial" panose="020B0604020202020204" pitchFamily="34" charset="0"/>
                <a:cs typeface="Arial" panose="020B0604020202020204" pitchFamily="34" charset="0"/>
              </a:rPr>
              <a:t>2D culture of human </a:t>
            </a:r>
            <a:r>
              <a:rPr lang="en-AU" sz="2000" dirty="0" err="1">
                <a:latin typeface="Arial" panose="020B0604020202020204" pitchFamily="34" charset="0"/>
                <a:cs typeface="Arial" panose="020B0604020202020204" pitchFamily="34" charset="0"/>
              </a:rPr>
              <a:t>iPSCs</a:t>
            </a:r>
            <a:r>
              <a:rPr lang="en-AU" sz="2000" dirty="0">
                <a:latin typeface="Arial" panose="020B0604020202020204" pitchFamily="34" charset="0"/>
                <a:cs typeface="Arial" panose="020B0604020202020204" pitchFamily="34" charset="0"/>
              </a:rPr>
              <a:t> 019</a:t>
            </a:r>
          </a:p>
          <a:p>
            <a:r>
              <a:rPr lang="en-AU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5: 25-Day </a:t>
            </a:r>
            <a:r>
              <a:rPr lang="en-AU" sz="2000" dirty="0">
                <a:latin typeface="Arial" panose="020B0604020202020204" pitchFamily="34" charset="0"/>
                <a:cs typeface="Arial" panose="020B0604020202020204" pitchFamily="34" charset="0"/>
              </a:rPr>
              <a:t>2D culture of human </a:t>
            </a:r>
            <a:r>
              <a:rPr lang="en-AU" sz="2000" dirty="0" err="1">
                <a:latin typeface="Arial" panose="020B0604020202020204" pitchFamily="34" charset="0"/>
                <a:cs typeface="Arial" panose="020B0604020202020204" pitchFamily="34" charset="0"/>
              </a:rPr>
              <a:t>iPSCs</a:t>
            </a:r>
            <a:r>
              <a:rPr lang="en-AU" sz="2000" dirty="0">
                <a:latin typeface="Arial" panose="020B0604020202020204" pitchFamily="34" charset="0"/>
                <a:cs typeface="Arial" panose="020B0604020202020204" pitchFamily="34" charset="0"/>
              </a:rPr>
              <a:t> 019</a:t>
            </a:r>
          </a:p>
          <a:p>
            <a:r>
              <a:rPr lang="en-AU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6: 17-Day 3D </a:t>
            </a:r>
            <a:r>
              <a:rPr lang="en-AU" sz="2000" dirty="0">
                <a:latin typeface="Arial" panose="020B0604020202020204" pitchFamily="34" charset="0"/>
                <a:cs typeface="Arial" panose="020B0604020202020204" pitchFamily="34" charset="0"/>
              </a:rPr>
              <a:t>culture of human </a:t>
            </a:r>
            <a:r>
              <a:rPr lang="en-AU" sz="2000" dirty="0" err="1">
                <a:latin typeface="Arial" panose="020B0604020202020204" pitchFamily="34" charset="0"/>
                <a:cs typeface="Arial" panose="020B0604020202020204" pitchFamily="34" charset="0"/>
              </a:rPr>
              <a:t>iPSCs</a:t>
            </a:r>
            <a:r>
              <a:rPr lang="en-AU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AU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019</a:t>
            </a:r>
          </a:p>
          <a:p>
            <a:r>
              <a:rPr lang="en-AU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NTC: no template control</a:t>
            </a:r>
          </a:p>
          <a:p>
            <a:r>
              <a:rPr lang="en-AU" sz="2000" dirty="0">
                <a:latin typeface="Arial" panose="020B0604020202020204" pitchFamily="34" charset="0"/>
                <a:cs typeface="Arial" panose="020B0604020202020204" pitchFamily="34" charset="0"/>
              </a:rPr>
              <a:t>Arrow: expected size of </a:t>
            </a:r>
            <a:r>
              <a:rPr lang="en-AU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amplicons</a:t>
            </a:r>
            <a:endParaRPr lang="en-AU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719729" y="885176"/>
            <a:ext cx="192392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Human</a:t>
            </a:r>
            <a:r>
              <a:rPr lang="en-AU" sz="2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FOXA2</a:t>
            </a:r>
            <a:endParaRPr lang="en-US" sz="2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Straight Arrow Connector 36"/>
          <p:cNvCxnSpPr/>
          <p:nvPr/>
        </p:nvCxnSpPr>
        <p:spPr>
          <a:xfrm flipH="1">
            <a:off x="7573137" y="2989195"/>
            <a:ext cx="357352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99152" y="109931"/>
            <a:ext cx="797526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AU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data: Raw data of agarose gel with labels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7055537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48708" y="1615660"/>
            <a:ext cx="5715000" cy="4276725"/>
          </a:xfrm>
          <a:prstGeom prst="rect">
            <a:avLst/>
          </a:prstGeom>
        </p:spPr>
      </p:pic>
      <p:cxnSp>
        <p:nvCxnSpPr>
          <p:cNvPr id="4" name="Straight Connector 3"/>
          <p:cNvCxnSpPr/>
          <p:nvPr/>
        </p:nvCxnSpPr>
        <p:spPr>
          <a:xfrm flipH="1">
            <a:off x="1600195" y="4400097"/>
            <a:ext cx="21515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Connector 4"/>
          <p:cNvCxnSpPr/>
          <p:nvPr/>
        </p:nvCxnSpPr>
        <p:spPr>
          <a:xfrm flipH="1">
            <a:off x="1612153" y="4064024"/>
            <a:ext cx="21515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 flipH="1">
            <a:off x="1612154" y="3848189"/>
            <a:ext cx="21515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 flipH="1">
            <a:off x="1612155" y="3691308"/>
            <a:ext cx="21515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/>
          <p:cNvCxnSpPr/>
          <p:nvPr/>
        </p:nvCxnSpPr>
        <p:spPr>
          <a:xfrm flipH="1">
            <a:off x="1614888" y="3561924"/>
            <a:ext cx="21515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/>
          <p:cNvCxnSpPr/>
          <p:nvPr/>
        </p:nvCxnSpPr>
        <p:spPr>
          <a:xfrm flipH="1">
            <a:off x="1614889" y="3390512"/>
            <a:ext cx="21515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 flipH="1">
            <a:off x="1618120" y="3093047"/>
            <a:ext cx="21515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 flipH="1">
            <a:off x="1618120" y="2939945"/>
            <a:ext cx="21515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1277596" y="4284681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1273501" y="3941294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273501" y="3732165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AU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0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1270700" y="3570130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400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1281325" y="3435646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AU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0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273501" y="3243383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lang="en-AU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0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1219019" y="2969971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500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1222662" y="2806783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3000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Straight Connector 19"/>
          <p:cNvCxnSpPr/>
          <p:nvPr/>
        </p:nvCxnSpPr>
        <p:spPr>
          <a:xfrm flipH="1">
            <a:off x="1614889" y="3236102"/>
            <a:ext cx="21515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1211733" y="3102128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1351498" y="2640024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3119920" y="1290757"/>
            <a:ext cx="41576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>
                <a:latin typeface="Arial" panose="020B0604020202020204" pitchFamily="34" charset="0"/>
                <a:cs typeface="Arial" panose="020B0604020202020204" pitchFamily="34" charset="0"/>
              </a:rPr>
              <a:t>   M    1    2    3    4    5    6   NTC    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1830042" y="6188975"/>
            <a:ext cx="4956806" cy="28623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M: 100-bp DNA ladder</a:t>
            </a:r>
          </a:p>
          <a:p>
            <a:r>
              <a:rPr lang="en-AU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1: Human </a:t>
            </a:r>
            <a:r>
              <a:rPr lang="en-AU" sz="2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PSCs</a:t>
            </a:r>
            <a:r>
              <a:rPr lang="en-AU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 019</a:t>
            </a:r>
          </a:p>
          <a:p>
            <a:r>
              <a:rPr lang="en-AU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2: 5-Day 2D culture of human </a:t>
            </a:r>
            <a:r>
              <a:rPr lang="en-AU" sz="2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PSCs</a:t>
            </a:r>
            <a:r>
              <a:rPr lang="en-AU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 019</a:t>
            </a:r>
          </a:p>
          <a:p>
            <a:r>
              <a:rPr lang="en-AU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3: 10-Day 2D culture </a:t>
            </a:r>
            <a:r>
              <a:rPr lang="en-AU" sz="2000" dirty="0">
                <a:latin typeface="Arial" panose="020B0604020202020204" pitchFamily="34" charset="0"/>
                <a:cs typeface="Arial" panose="020B0604020202020204" pitchFamily="34" charset="0"/>
              </a:rPr>
              <a:t>of human </a:t>
            </a:r>
            <a:r>
              <a:rPr lang="en-AU" sz="2000" dirty="0" err="1">
                <a:latin typeface="Arial" panose="020B0604020202020204" pitchFamily="34" charset="0"/>
                <a:cs typeface="Arial" panose="020B0604020202020204" pitchFamily="34" charset="0"/>
              </a:rPr>
              <a:t>iPSCs</a:t>
            </a:r>
            <a:r>
              <a:rPr lang="en-AU" sz="2000" dirty="0">
                <a:latin typeface="Arial" panose="020B0604020202020204" pitchFamily="34" charset="0"/>
                <a:cs typeface="Arial" panose="020B0604020202020204" pitchFamily="34" charset="0"/>
              </a:rPr>
              <a:t> 019</a:t>
            </a:r>
          </a:p>
          <a:p>
            <a:r>
              <a:rPr lang="en-AU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4: 15-Day </a:t>
            </a:r>
            <a:r>
              <a:rPr lang="en-AU" sz="2000" dirty="0">
                <a:latin typeface="Arial" panose="020B0604020202020204" pitchFamily="34" charset="0"/>
                <a:cs typeface="Arial" panose="020B0604020202020204" pitchFamily="34" charset="0"/>
              </a:rPr>
              <a:t>2D culture of human </a:t>
            </a:r>
            <a:r>
              <a:rPr lang="en-AU" sz="2000" dirty="0" err="1">
                <a:latin typeface="Arial" panose="020B0604020202020204" pitchFamily="34" charset="0"/>
                <a:cs typeface="Arial" panose="020B0604020202020204" pitchFamily="34" charset="0"/>
              </a:rPr>
              <a:t>iPSCs</a:t>
            </a:r>
            <a:r>
              <a:rPr lang="en-AU" sz="2000" dirty="0">
                <a:latin typeface="Arial" panose="020B0604020202020204" pitchFamily="34" charset="0"/>
                <a:cs typeface="Arial" panose="020B0604020202020204" pitchFamily="34" charset="0"/>
              </a:rPr>
              <a:t> 019</a:t>
            </a:r>
          </a:p>
          <a:p>
            <a:r>
              <a:rPr lang="en-AU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5: 25-Day </a:t>
            </a:r>
            <a:r>
              <a:rPr lang="en-AU" sz="2000" dirty="0">
                <a:latin typeface="Arial" panose="020B0604020202020204" pitchFamily="34" charset="0"/>
                <a:cs typeface="Arial" panose="020B0604020202020204" pitchFamily="34" charset="0"/>
              </a:rPr>
              <a:t>2D culture of human </a:t>
            </a:r>
            <a:r>
              <a:rPr lang="en-AU" sz="2000" dirty="0" err="1">
                <a:latin typeface="Arial" panose="020B0604020202020204" pitchFamily="34" charset="0"/>
                <a:cs typeface="Arial" panose="020B0604020202020204" pitchFamily="34" charset="0"/>
              </a:rPr>
              <a:t>iPSCs</a:t>
            </a:r>
            <a:r>
              <a:rPr lang="en-AU" sz="2000" dirty="0">
                <a:latin typeface="Arial" panose="020B0604020202020204" pitchFamily="34" charset="0"/>
                <a:cs typeface="Arial" panose="020B0604020202020204" pitchFamily="34" charset="0"/>
              </a:rPr>
              <a:t> 019</a:t>
            </a:r>
          </a:p>
          <a:p>
            <a:r>
              <a:rPr lang="en-AU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6: 17-Day 3D </a:t>
            </a:r>
            <a:r>
              <a:rPr lang="en-AU" sz="2000" dirty="0">
                <a:latin typeface="Arial" panose="020B0604020202020204" pitchFamily="34" charset="0"/>
                <a:cs typeface="Arial" panose="020B0604020202020204" pitchFamily="34" charset="0"/>
              </a:rPr>
              <a:t>culture of human </a:t>
            </a:r>
            <a:r>
              <a:rPr lang="en-AU" sz="2000" dirty="0" err="1">
                <a:latin typeface="Arial" panose="020B0604020202020204" pitchFamily="34" charset="0"/>
                <a:cs typeface="Arial" panose="020B0604020202020204" pitchFamily="34" charset="0"/>
              </a:rPr>
              <a:t>iPSCs</a:t>
            </a:r>
            <a:r>
              <a:rPr lang="en-AU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AU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019</a:t>
            </a:r>
          </a:p>
          <a:p>
            <a:r>
              <a:rPr lang="en-AU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NTC: no template control</a:t>
            </a:r>
          </a:p>
          <a:p>
            <a:r>
              <a:rPr lang="en-AU" sz="2000" dirty="0">
                <a:latin typeface="Arial" panose="020B0604020202020204" pitchFamily="34" charset="0"/>
                <a:cs typeface="Arial" panose="020B0604020202020204" pitchFamily="34" charset="0"/>
              </a:rPr>
              <a:t>Arrow: expected size of </a:t>
            </a:r>
            <a:r>
              <a:rPr lang="en-AU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amplicons</a:t>
            </a:r>
            <a:endParaRPr lang="en-AU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719729" y="885176"/>
            <a:ext cx="157299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Human</a:t>
            </a:r>
            <a:r>
              <a:rPr lang="en-AU" sz="2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AFP</a:t>
            </a:r>
            <a:endParaRPr lang="en-US" sz="2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Straight Arrow Connector 36"/>
          <p:cNvCxnSpPr/>
          <p:nvPr/>
        </p:nvCxnSpPr>
        <p:spPr>
          <a:xfrm flipH="1">
            <a:off x="7584154" y="3862830"/>
            <a:ext cx="357352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99152" y="109931"/>
            <a:ext cx="797526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AU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data: Raw data of agarose gel with labels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7161790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78868" y="1791693"/>
            <a:ext cx="5715000" cy="4276725"/>
          </a:xfrm>
          <a:prstGeom prst="rect">
            <a:avLst/>
          </a:prstGeom>
        </p:spPr>
      </p:pic>
      <p:cxnSp>
        <p:nvCxnSpPr>
          <p:cNvPr id="4" name="Straight Connector 3"/>
          <p:cNvCxnSpPr/>
          <p:nvPr/>
        </p:nvCxnSpPr>
        <p:spPr>
          <a:xfrm flipH="1">
            <a:off x="1600195" y="4400097"/>
            <a:ext cx="21515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Connector 4"/>
          <p:cNvCxnSpPr/>
          <p:nvPr/>
        </p:nvCxnSpPr>
        <p:spPr>
          <a:xfrm flipH="1">
            <a:off x="1612153" y="4064024"/>
            <a:ext cx="21515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 flipH="1">
            <a:off x="1612154" y="3875084"/>
            <a:ext cx="21515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 flipH="1">
            <a:off x="1612155" y="3712824"/>
            <a:ext cx="21515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/>
          <p:cNvCxnSpPr/>
          <p:nvPr/>
        </p:nvCxnSpPr>
        <p:spPr>
          <a:xfrm flipH="1">
            <a:off x="1614888" y="3599577"/>
            <a:ext cx="21515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/>
          <p:cNvCxnSpPr/>
          <p:nvPr/>
        </p:nvCxnSpPr>
        <p:spPr>
          <a:xfrm flipH="1">
            <a:off x="1614889" y="3449681"/>
            <a:ext cx="21515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 flipH="1">
            <a:off x="1618120" y="3173727"/>
            <a:ext cx="21515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 flipH="1">
            <a:off x="1618120" y="3042143"/>
            <a:ext cx="21515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1277596" y="4284681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1273501" y="3941294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284259" y="3759060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AU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0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1286837" y="3597025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400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1297462" y="3473299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AU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0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297462" y="3319350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lang="en-AU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0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1241441" y="3056513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500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1241441" y="2930321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3000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Straight Connector 19"/>
          <p:cNvCxnSpPr/>
          <p:nvPr/>
        </p:nvCxnSpPr>
        <p:spPr>
          <a:xfrm flipH="1">
            <a:off x="1614889" y="3295271"/>
            <a:ext cx="21515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1241441" y="3182705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1368868" y="2716788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3195224" y="1483782"/>
            <a:ext cx="41576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>
                <a:latin typeface="Arial" panose="020B0604020202020204" pitchFamily="34" charset="0"/>
                <a:cs typeface="Arial" panose="020B0604020202020204" pitchFamily="34" charset="0"/>
              </a:rPr>
              <a:t>   M    1    2    3     4    5    6   NTC    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1830042" y="6188975"/>
            <a:ext cx="4956806" cy="28623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M: 100-bp DNA ladder</a:t>
            </a:r>
          </a:p>
          <a:p>
            <a:r>
              <a:rPr lang="en-AU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1: Human </a:t>
            </a:r>
            <a:r>
              <a:rPr lang="en-AU" sz="2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PSCs</a:t>
            </a:r>
            <a:r>
              <a:rPr lang="en-AU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 019</a:t>
            </a:r>
          </a:p>
          <a:p>
            <a:r>
              <a:rPr lang="en-AU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2: 5-Day 2D culture of human </a:t>
            </a:r>
            <a:r>
              <a:rPr lang="en-AU" sz="2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PSCs</a:t>
            </a:r>
            <a:r>
              <a:rPr lang="en-AU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 019</a:t>
            </a:r>
          </a:p>
          <a:p>
            <a:r>
              <a:rPr lang="en-AU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3: 10-Day 2D culture </a:t>
            </a:r>
            <a:r>
              <a:rPr lang="en-AU" sz="2000" dirty="0">
                <a:latin typeface="Arial" panose="020B0604020202020204" pitchFamily="34" charset="0"/>
                <a:cs typeface="Arial" panose="020B0604020202020204" pitchFamily="34" charset="0"/>
              </a:rPr>
              <a:t>of human </a:t>
            </a:r>
            <a:r>
              <a:rPr lang="en-AU" sz="2000" dirty="0" err="1">
                <a:latin typeface="Arial" panose="020B0604020202020204" pitchFamily="34" charset="0"/>
                <a:cs typeface="Arial" panose="020B0604020202020204" pitchFamily="34" charset="0"/>
              </a:rPr>
              <a:t>iPSCs</a:t>
            </a:r>
            <a:r>
              <a:rPr lang="en-AU" sz="2000" dirty="0">
                <a:latin typeface="Arial" panose="020B0604020202020204" pitchFamily="34" charset="0"/>
                <a:cs typeface="Arial" panose="020B0604020202020204" pitchFamily="34" charset="0"/>
              </a:rPr>
              <a:t> 019</a:t>
            </a:r>
          </a:p>
          <a:p>
            <a:r>
              <a:rPr lang="en-AU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4: 15-Day </a:t>
            </a:r>
            <a:r>
              <a:rPr lang="en-AU" sz="2000" dirty="0">
                <a:latin typeface="Arial" panose="020B0604020202020204" pitchFamily="34" charset="0"/>
                <a:cs typeface="Arial" panose="020B0604020202020204" pitchFamily="34" charset="0"/>
              </a:rPr>
              <a:t>2D culture of human </a:t>
            </a:r>
            <a:r>
              <a:rPr lang="en-AU" sz="2000" dirty="0" err="1">
                <a:latin typeface="Arial" panose="020B0604020202020204" pitchFamily="34" charset="0"/>
                <a:cs typeface="Arial" panose="020B0604020202020204" pitchFamily="34" charset="0"/>
              </a:rPr>
              <a:t>iPSCs</a:t>
            </a:r>
            <a:r>
              <a:rPr lang="en-AU" sz="2000" dirty="0">
                <a:latin typeface="Arial" panose="020B0604020202020204" pitchFamily="34" charset="0"/>
                <a:cs typeface="Arial" panose="020B0604020202020204" pitchFamily="34" charset="0"/>
              </a:rPr>
              <a:t> 019</a:t>
            </a:r>
          </a:p>
          <a:p>
            <a:r>
              <a:rPr lang="en-AU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5: 25-Day </a:t>
            </a:r>
            <a:r>
              <a:rPr lang="en-AU" sz="2000" dirty="0">
                <a:latin typeface="Arial" panose="020B0604020202020204" pitchFamily="34" charset="0"/>
                <a:cs typeface="Arial" panose="020B0604020202020204" pitchFamily="34" charset="0"/>
              </a:rPr>
              <a:t>2D culture of human </a:t>
            </a:r>
            <a:r>
              <a:rPr lang="en-AU" sz="2000" dirty="0" err="1">
                <a:latin typeface="Arial" panose="020B0604020202020204" pitchFamily="34" charset="0"/>
                <a:cs typeface="Arial" panose="020B0604020202020204" pitchFamily="34" charset="0"/>
              </a:rPr>
              <a:t>iPSCs</a:t>
            </a:r>
            <a:r>
              <a:rPr lang="en-AU" sz="2000" dirty="0">
                <a:latin typeface="Arial" panose="020B0604020202020204" pitchFamily="34" charset="0"/>
                <a:cs typeface="Arial" panose="020B0604020202020204" pitchFamily="34" charset="0"/>
              </a:rPr>
              <a:t> 019</a:t>
            </a:r>
          </a:p>
          <a:p>
            <a:r>
              <a:rPr lang="en-AU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6: 17-Day 3D </a:t>
            </a:r>
            <a:r>
              <a:rPr lang="en-AU" sz="2000" dirty="0">
                <a:latin typeface="Arial" panose="020B0604020202020204" pitchFamily="34" charset="0"/>
                <a:cs typeface="Arial" panose="020B0604020202020204" pitchFamily="34" charset="0"/>
              </a:rPr>
              <a:t>culture of human </a:t>
            </a:r>
            <a:r>
              <a:rPr lang="en-AU" sz="2000" dirty="0" err="1">
                <a:latin typeface="Arial" panose="020B0604020202020204" pitchFamily="34" charset="0"/>
                <a:cs typeface="Arial" panose="020B0604020202020204" pitchFamily="34" charset="0"/>
              </a:rPr>
              <a:t>iPSCs</a:t>
            </a:r>
            <a:r>
              <a:rPr lang="en-AU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AU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019</a:t>
            </a:r>
          </a:p>
          <a:p>
            <a:r>
              <a:rPr lang="en-AU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NTC: no template control</a:t>
            </a:r>
          </a:p>
          <a:p>
            <a:r>
              <a:rPr lang="en-AU" sz="2000" dirty="0">
                <a:latin typeface="Arial" panose="020B0604020202020204" pitchFamily="34" charset="0"/>
                <a:cs typeface="Arial" panose="020B0604020202020204" pitchFamily="34" charset="0"/>
              </a:rPr>
              <a:t>Arrow: expected size of </a:t>
            </a:r>
            <a:r>
              <a:rPr lang="en-AU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amplicons</a:t>
            </a:r>
            <a:endParaRPr lang="en-AU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719729" y="885176"/>
            <a:ext cx="155856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Human</a:t>
            </a:r>
            <a:r>
              <a:rPr lang="en-AU" sz="2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ALB</a:t>
            </a:r>
            <a:endParaRPr lang="en-US" sz="2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Straight Arrow Connector 36"/>
          <p:cNvCxnSpPr/>
          <p:nvPr/>
        </p:nvCxnSpPr>
        <p:spPr>
          <a:xfrm flipH="1">
            <a:off x="7628220" y="3765986"/>
            <a:ext cx="357352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99152" y="109931"/>
            <a:ext cx="797526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AU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data: Raw data of agarose gel with labels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8132212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70923" y="2107440"/>
            <a:ext cx="5715000" cy="4276725"/>
          </a:xfrm>
          <a:prstGeom prst="rect">
            <a:avLst/>
          </a:prstGeom>
        </p:spPr>
      </p:pic>
      <p:cxnSp>
        <p:nvCxnSpPr>
          <p:cNvPr id="10" name="Straight Connector 9"/>
          <p:cNvCxnSpPr/>
          <p:nvPr/>
        </p:nvCxnSpPr>
        <p:spPr>
          <a:xfrm flipH="1">
            <a:off x="1600195" y="4741236"/>
            <a:ext cx="21515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 flipH="1">
            <a:off x="1600194" y="4443160"/>
            <a:ext cx="21515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 flipH="1">
            <a:off x="1600194" y="4245802"/>
            <a:ext cx="21515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 flipH="1">
            <a:off x="1600194" y="4095643"/>
            <a:ext cx="21515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 flipH="1">
            <a:off x="1604675" y="3979102"/>
            <a:ext cx="21515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 flipH="1">
            <a:off x="1600193" y="3876007"/>
            <a:ext cx="21515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 flipH="1">
            <a:off x="1618120" y="3524142"/>
            <a:ext cx="21515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 flipH="1">
            <a:off x="1618120" y="3380707"/>
            <a:ext cx="21515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1277596" y="4625820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1277596" y="4332416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1272025" y="4140475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AU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0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1264924" y="3990885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400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1264924" y="3848075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AU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0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1264924" y="3736372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AU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0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1207905" y="3404927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500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200804" y="3262117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3000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Straight Connector 25"/>
          <p:cNvCxnSpPr/>
          <p:nvPr/>
        </p:nvCxnSpPr>
        <p:spPr>
          <a:xfrm flipH="1">
            <a:off x="1614889" y="3649800"/>
            <a:ext cx="21515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1207905" y="3538276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329044" y="306247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3122550" y="1788471"/>
            <a:ext cx="61958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>
                <a:latin typeface="Arial" panose="020B0604020202020204" pitchFamily="34" charset="0"/>
                <a:cs typeface="Arial" panose="020B0604020202020204" pitchFamily="34" charset="0"/>
              </a:rPr>
              <a:t>   M    1    2    3    4     5    6    NTC    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1830042" y="6530114"/>
            <a:ext cx="4956806" cy="28623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M: 100-bp DNA ladder</a:t>
            </a:r>
          </a:p>
          <a:p>
            <a:r>
              <a:rPr lang="en-AU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1: Human </a:t>
            </a:r>
            <a:r>
              <a:rPr lang="en-AU" sz="2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PSCs</a:t>
            </a:r>
            <a:r>
              <a:rPr lang="en-AU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 019</a:t>
            </a:r>
          </a:p>
          <a:p>
            <a:r>
              <a:rPr lang="en-AU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2: 5-Day 2D culture of human </a:t>
            </a:r>
            <a:r>
              <a:rPr lang="en-AU" sz="2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PSCs</a:t>
            </a:r>
            <a:r>
              <a:rPr lang="en-AU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 019</a:t>
            </a:r>
          </a:p>
          <a:p>
            <a:r>
              <a:rPr lang="en-AU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3: 10-Day 2D culture </a:t>
            </a:r>
            <a:r>
              <a:rPr lang="en-AU" sz="2000" dirty="0">
                <a:latin typeface="Arial" panose="020B0604020202020204" pitchFamily="34" charset="0"/>
                <a:cs typeface="Arial" panose="020B0604020202020204" pitchFamily="34" charset="0"/>
              </a:rPr>
              <a:t>of human </a:t>
            </a:r>
            <a:r>
              <a:rPr lang="en-AU" sz="2000" dirty="0" err="1">
                <a:latin typeface="Arial" panose="020B0604020202020204" pitchFamily="34" charset="0"/>
                <a:cs typeface="Arial" panose="020B0604020202020204" pitchFamily="34" charset="0"/>
              </a:rPr>
              <a:t>iPSCs</a:t>
            </a:r>
            <a:r>
              <a:rPr lang="en-AU" sz="2000" dirty="0">
                <a:latin typeface="Arial" panose="020B0604020202020204" pitchFamily="34" charset="0"/>
                <a:cs typeface="Arial" panose="020B0604020202020204" pitchFamily="34" charset="0"/>
              </a:rPr>
              <a:t> 019</a:t>
            </a:r>
          </a:p>
          <a:p>
            <a:r>
              <a:rPr lang="en-AU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4: 15-Day </a:t>
            </a:r>
            <a:r>
              <a:rPr lang="en-AU" sz="2000" dirty="0">
                <a:latin typeface="Arial" panose="020B0604020202020204" pitchFamily="34" charset="0"/>
                <a:cs typeface="Arial" panose="020B0604020202020204" pitchFamily="34" charset="0"/>
              </a:rPr>
              <a:t>2D culture of human </a:t>
            </a:r>
            <a:r>
              <a:rPr lang="en-AU" sz="2000" dirty="0" err="1">
                <a:latin typeface="Arial" panose="020B0604020202020204" pitchFamily="34" charset="0"/>
                <a:cs typeface="Arial" panose="020B0604020202020204" pitchFamily="34" charset="0"/>
              </a:rPr>
              <a:t>iPSCs</a:t>
            </a:r>
            <a:r>
              <a:rPr lang="en-AU" sz="2000" dirty="0">
                <a:latin typeface="Arial" panose="020B0604020202020204" pitchFamily="34" charset="0"/>
                <a:cs typeface="Arial" panose="020B0604020202020204" pitchFamily="34" charset="0"/>
              </a:rPr>
              <a:t> 019</a:t>
            </a:r>
          </a:p>
          <a:p>
            <a:r>
              <a:rPr lang="en-AU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5: 25-Day </a:t>
            </a:r>
            <a:r>
              <a:rPr lang="en-AU" sz="2000" dirty="0">
                <a:latin typeface="Arial" panose="020B0604020202020204" pitchFamily="34" charset="0"/>
                <a:cs typeface="Arial" panose="020B0604020202020204" pitchFamily="34" charset="0"/>
              </a:rPr>
              <a:t>2D culture of human </a:t>
            </a:r>
            <a:r>
              <a:rPr lang="en-AU" sz="2000" dirty="0" err="1">
                <a:latin typeface="Arial" panose="020B0604020202020204" pitchFamily="34" charset="0"/>
                <a:cs typeface="Arial" panose="020B0604020202020204" pitchFamily="34" charset="0"/>
              </a:rPr>
              <a:t>iPSCs</a:t>
            </a:r>
            <a:r>
              <a:rPr lang="en-AU" sz="2000" dirty="0">
                <a:latin typeface="Arial" panose="020B0604020202020204" pitchFamily="34" charset="0"/>
                <a:cs typeface="Arial" panose="020B0604020202020204" pitchFamily="34" charset="0"/>
              </a:rPr>
              <a:t> 019</a:t>
            </a:r>
          </a:p>
          <a:p>
            <a:r>
              <a:rPr lang="en-AU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6: 17-Day 3D </a:t>
            </a:r>
            <a:r>
              <a:rPr lang="en-AU" sz="2000" dirty="0">
                <a:latin typeface="Arial" panose="020B0604020202020204" pitchFamily="34" charset="0"/>
                <a:cs typeface="Arial" panose="020B0604020202020204" pitchFamily="34" charset="0"/>
              </a:rPr>
              <a:t>culture of human </a:t>
            </a:r>
            <a:r>
              <a:rPr lang="en-AU" sz="2000" dirty="0" err="1">
                <a:latin typeface="Arial" panose="020B0604020202020204" pitchFamily="34" charset="0"/>
                <a:cs typeface="Arial" panose="020B0604020202020204" pitchFamily="34" charset="0"/>
              </a:rPr>
              <a:t>iPSCs</a:t>
            </a:r>
            <a:r>
              <a:rPr lang="en-AU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AU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019</a:t>
            </a:r>
          </a:p>
          <a:p>
            <a:r>
              <a:rPr lang="en-AU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NTC: no template control</a:t>
            </a:r>
          </a:p>
          <a:p>
            <a:r>
              <a:rPr lang="en-AU" sz="2000" dirty="0">
                <a:latin typeface="Arial" panose="020B0604020202020204" pitchFamily="34" charset="0"/>
                <a:cs typeface="Arial" panose="020B0604020202020204" pitchFamily="34" charset="0"/>
              </a:rPr>
              <a:t>Arrow: expected size of </a:t>
            </a:r>
            <a:r>
              <a:rPr lang="en-AU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amplicons</a:t>
            </a:r>
            <a:endParaRPr lang="en-AU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1722465" y="1091408"/>
            <a:ext cx="175894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Human</a:t>
            </a:r>
            <a:r>
              <a:rPr lang="en-AU" sz="2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ACTB</a:t>
            </a:r>
            <a:endParaRPr lang="en-US" sz="2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6" name="Straight Arrow Connector 45"/>
          <p:cNvCxnSpPr/>
          <p:nvPr/>
        </p:nvCxnSpPr>
        <p:spPr>
          <a:xfrm flipH="1">
            <a:off x="7584154" y="4645027"/>
            <a:ext cx="357352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/>
          <p:cNvSpPr txBox="1"/>
          <p:nvPr/>
        </p:nvSpPr>
        <p:spPr>
          <a:xfrm>
            <a:off x="99152" y="109931"/>
            <a:ext cx="797526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AU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data: Raw data of agarose gel with labels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817901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</TotalTime>
  <Words>485</Words>
  <Application>Microsoft Office PowerPoint</Application>
  <PresentationFormat>Custom</PresentationFormat>
  <Paragraphs>110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LL</dc:creator>
  <cp:lastModifiedBy>DELL</cp:lastModifiedBy>
  <cp:revision>12</cp:revision>
  <dcterms:created xsi:type="dcterms:W3CDTF">2020-08-01T03:52:27Z</dcterms:created>
  <dcterms:modified xsi:type="dcterms:W3CDTF">2020-08-01T04:32:00Z</dcterms:modified>
</cp:coreProperties>
</file>